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BEDDC8-B4CC-4AFA-92F3-34CBF5DFB0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7FEE5C-44EA-437B-A7F3-6104D1BA18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65DCD2-010D-4A92-B0E3-F32ACCB127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E6EB87-9CED-4DE6-9836-18ABBC3B97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AFFEE-94D2-40AD-874F-35CAAFB6AA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6F040-70B6-4FA1-9B2E-01C130980E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1F914-C0F7-4C0E-9956-9A0D80D5FD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3E610B-333D-467D-BA3D-A1B8013820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6B817-CD50-4707-A4C6-A2C5C00DAA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5BBDB-2C4F-46A7-8BB8-AF7047261E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3CD05A-C44C-4CF8-8E00-76E974CCAA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8A5C43-FBF0-415F-B91B-CE6465F97D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C72925-5138-44C1-A358-14AF1785E0B4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399600" y="353160"/>
            <a:ext cx="5682240" cy="5210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tggaatcc tgcggcggcg gcggcggcgg cgacagcggg cgagccaggg cccgggcggg     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gagtgggcg agcgggtagg cccaaggcta ttgtcgtcgc tgctgccatg gctttttcat    1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gagggccta aagtaatcgc gctaagaata aa</a:t>
            </a:r>
            <a:r>
              <a:rPr b="0" lang="it-IT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gggaaaa</a:t>
            </a: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 </a:t>
            </a:r>
            <a:r>
              <a:rPr b="1" lang="it-IT" sz="1400" spc="-1" strike="noStrike">
                <a:solidFill>
                  <a:srgbClr val="0070c0"/>
                </a:solidFill>
                <a:latin typeface="Courier New"/>
                <a:ea typeface="Times New Roman"/>
              </a:rPr>
              <a:t>G/A</a:t>
            </a: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cgtcgccc tcatttcaac 1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cactccta cccccttcct caacccccaa acaaaacaaa caaacttccc tggcttcgca    2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tgcctggg gcctcgcagc ggggccaggg ctccgcctgc tgatcggggg ttgtgagcag    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gcggcctgg acgcggggca ctctcagggg gctgtgtctg cgtgtcagtt tgtgtctgtc    3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ggggaatg tgtgtctgtg gcccaagcag gtgacaggaa gagatggggg gcctcaacca    4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cttagtgac ttgtttagaa aaaaaagaca aaaaagtaaa aataaaaaca aaaaagttgg    4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aggcagaaa ccattaaaaa acaaaaagcc aacaacccag aaaggtttaa aaaacataag    5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aaaaaaaag acaaattaaa ggaggggcta ggggagaagc tgcagctgga gctgaaggct    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gatcttgtg aacccctaaa tccgctccct cctaacagca cggattctct tggggctctt    6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ttcagggaa gagtagggac gccgttccag ccccccttcc tatcgtgtcc ttgggttcgg    7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tcactgcgg cgacgacttg ctcagactgt cccggcggcc ggagtgactt tctcgcaccc    7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ttgcctgt cccacctcgc tgaacaccat cccgccatta gcgcatcgga accccacaca    8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ttgcaactc ccaaccccga atctttgcag ccgttcggcc ctgaaagatg ccctatccat    9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agatgcctt ttcatctgca aactctgcaa aatgtgtctc atgtttcgca actctttttt    9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cccctcgc tcccgcctac cccgtcggca ttttcttctt ccaccagctt ttactgaact   10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tttggcact gctttggatt ggggtcaatt gcagtccacg taactggctg cagagaaatc   10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accgagcaa ggaaaaggca cacacacacg tttgcagggg tgtctcggtt tgcatttctg   11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tggaatgat ccgaactgga ctcacatcct gtatggtgga tggactgtat attgagggtt   1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attcttcg cgcagtttag acatctctgt tttgattctt tgttgttgtt tttattttaa   12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aggcacaaa ctctagatat tagttgaatg ttgaggcttt aactttttcg gtgtctttct   13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caactgtgt tctgtgactc aattgtatcg tgttaatatc agtgcagact gtctcctcta   13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gtgaccgta taatgttttt ctcttcttgt agtctctatg gcgtgtcttt atggtgtaat   14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aggttctca cgggttcaat cttttgtgtt tagagaggcc acggttcaga caatggtata   1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atttttgtt atcaggtgca tgtctgtctg atttcttttt ttttcctgtt ggactatgtt   15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gtgaacata attgtcataa gttatgtttc agatttttga atttatttat atgtgttata   16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tgaatgctt ctattta</a:t>
            </a:r>
            <a:r>
              <a:rPr b="0" lang="it-IT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aaa ggg</a:t>
            </a: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aatatt tctacatgtg c</a:t>
            </a:r>
            <a:r>
              <a:rPr b="1" lang="it-IT" sz="1400" spc="-1" strike="noStrike">
                <a:solidFill>
                  <a:srgbClr val="c00000"/>
                </a:solidFill>
                <a:latin typeface="Courier New"/>
                <a:ea typeface="Times New Roman"/>
              </a:rPr>
              <a:t>A/T</a:t>
            </a: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atagttt</a:t>
            </a:r>
            <a:r>
              <a:rPr b="0" lang="it-IT" sz="1000" spc="-1" strike="noStrike">
                <a:solidFill>
                  <a:srgbClr val="c00000"/>
                </a:solidFill>
                <a:latin typeface="Courier New"/>
                <a:ea typeface="Times New Roman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caagagtg16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accattaac ttgattgttg ataataaaaa caaaaagcaa gtctaaaa</a:t>
            </a:r>
            <a:r>
              <a:rPr b="0" i="1" lang="it-IT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ttangolo 7"/>
          <p:cNvSpPr/>
          <p:nvPr/>
        </p:nvSpPr>
        <p:spPr>
          <a:xfrm>
            <a:off x="3681360" y="4930920"/>
            <a:ext cx="83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c00000"/>
                </a:solidFill>
                <a:latin typeface="Calibri"/>
              </a:rPr>
              <a:t>rs10636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ttangolo 9"/>
          <p:cNvSpPr/>
          <p:nvPr/>
        </p:nvSpPr>
        <p:spPr>
          <a:xfrm>
            <a:off x="3683160" y="765000"/>
            <a:ext cx="99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70c0"/>
                </a:solidFill>
                <a:latin typeface="Calibri"/>
              </a:rPr>
              <a:t>rs11429049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CasellaDiTesto 1"/>
          <p:cNvSpPr/>
          <p:nvPr/>
        </p:nvSpPr>
        <p:spPr>
          <a:xfrm>
            <a:off x="1725480" y="4930920"/>
            <a:ext cx="1514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c00000"/>
                </a:solidFill>
                <a:latin typeface="Arial"/>
              </a:rPr>
              <a:t>D-20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CasellaDiTesto 1"/>
          <p:cNvSpPr/>
          <p:nvPr/>
        </p:nvSpPr>
        <p:spPr>
          <a:xfrm>
            <a:off x="3057480" y="749160"/>
            <a:ext cx="717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70c0"/>
                </a:solidFill>
                <a:latin typeface="Arial"/>
              </a:rPr>
              <a:t>P-20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8-11T12:31:07Z</dcterms:created>
  <dc:creator>genmol</dc:creator>
  <dc:description/>
  <dc:language>en-US</dc:language>
  <cp:lastModifiedBy>Tiziana Bachetti</cp:lastModifiedBy>
  <dcterms:modified xsi:type="dcterms:W3CDTF">2020-12-16T11:59:13Z</dcterms:modified>
  <cp:revision>15</cp:revision>
  <dc:subject/>
  <dc:title>Diapositiva 1</dc:title>
</cp:coreProperties>
</file>